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0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3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339191"/>
            <a:ext cx="741682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Lee 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403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hared genomic regions between type 2 diabetes and coronary artery disease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99B9874-0258-67BC-A6EE-BD2D9C418E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35842" y="980728"/>
            <a:ext cx="5672316" cy="45958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16024" y="272842"/>
            <a:ext cx="88924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Precision risk evaluation of type 2 diabetes-related CVD using genetic information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A90B810-AA15-E5FE-88CE-9513FE6A25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792" y="1119555"/>
            <a:ext cx="8316416" cy="432566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08B10ED-257F-3B4D-053E-411A82F4F368}"/>
              </a:ext>
            </a:extLst>
          </p:cNvPr>
          <p:cNvSpPr txBox="1"/>
          <p:nvPr/>
        </p:nvSpPr>
        <p:spPr>
          <a:xfrm>
            <a:off x="107504" y="5339191"/>
            <a:ext cx="7416824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Lee 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403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9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On-screen Show (4:3)</PresentationFormat>
  <Paragraphs>1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50</cp:revision>
  <dcterms:created xsi:type="dcterms:W3CDTF">2016-06-15T12:53:43Z</dcterms:created>
  <dcterms:modified xsi:type="dcterms:W3CDTF">2025-03-10T16:01:13Z</dcterms:modified>
</cp:coreProperties>
</file>